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83" r:id="rId2"/>
  </p:sldIdLst>
  <p:sldSz cx="6858000" cy="9906000" type="A4"/>
  <p:notesSz cx="7023100" cy="93091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B93D676-6387-CCB8-0E5B-9B64CD3A569A}" name="Kenchegowda, Doreswamy CTR (USA)" initials="DK" userId="S::doreswamy.kenchegowda.ctr@health.mil::4c011d48-4bee-4b9f-a323-16a4f7f79e55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218" autoAdjust="0"/>
    <p:restoredTop sz="96723" autoAdjust="0"/>
  </p:normalViewPr>
  <p:slideViewPr>
    <p:cSldViewPr>
      <p:cViewPr>
        <p:scale>
          <a:sx n="125" d="100"/>
          <a:sy n="125" d="100"/>
        </p:scale>
        <p:origin x="1238" y="-319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pelia Ion" userId="5e1e1f30-9db1-4155-873b-88338b1793ac" providerId="ADAL" clId="{94F51D4E-4498-4118-ABA3-9E0240516DE3}"/>
    <pc:docChg chg="modSld">
      <pc:chgData name="Apelia Ion" userId="5e1e1f30-9db1-4155-873b-88338b1793ac" providerId="ADAL" clId="{94F51D4E-4498-4118-ABA3-9E0240516DE3}" dt="2026-04-29T06:36:06.317" v="0" actId="20577"/>
      <pc:docMkLst>
        <pc:docMk/>
      </pc:docMkLst>
      <pc:sldChg chg="modSp mod">
        <pc:chgData name="Apelia Ion" userId="5e1e1f30-9db1-4155-873b-88338b1793ac" providerId="ADAL" clId="{94F51D4E-4498-4118-ABA3-9E0240516DE3}" dt="2026-04-29T06:36:06.317" v="0" actId="20577"/>
        <pc:sldMkLst>
          <pc:docMk/>
          <pc:sldMk cId="3776735790" sldId="283"/>
        </pc:sldMkLst>
        <pc:spChg chg="mod">
          <ac:chgData name="Apelia Ion" userId="5e1e1f30-9db1-4155-873b-88338b1793ac" providerId="ADAL" clId="{94F51D4E-4498-4118-ABA3-9E0240516DE3}" dt="2026-04-29T06:36:06.317" v="0" actId="20577"/>
          <ac:spMkLst>
            <pc:docMk/>
            <pc:sldMk cId="3776735790" sldId="283"/>
            <ac:spMk id="5" creationId="{EC922FD7-E12A-B51F-9639-CD8AD6523BF4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3238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8275" y="0"/>
            <a:ext cx="3043238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70887AE-46ED-456E-AEFB-3359CD807D3D}" type="datetimeFigureOut">
              <a:rPr lang="en-US" smtClean="0"/>
              <a:t>4/29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24113" y="1163638"/>
            <a:ext cx="2174875" cy="31416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9925"/>
            <a:ext cx="5619750" cy="36655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2375"/>
            <a:ext cx="3043238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8275" y="8842375"/>
            <a:ext cx="3043238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CB50BC-F0C7-4117-977E-15E1A4D2BB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53883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E1577-C933-41BD-993C-373F4518E1AF}" type="datetimeFigureOut">
              <a:rPr lang="en-US" smtClean="0"/>
              <a:t>4/2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4EBF1-75AD-4EB6-B7CC-5F2E1793C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5910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E1577-C933-41BD-993C-373F4518E1AF}" type="datetimeFigureOut">
              <a:rPr lang="en-US" smtClean="0"/>
              <a:t>4/2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4EBF1-75AD-4EB6-B7CC-5F2E1793C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3604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E1577-C933-41BD-993C-373F4518E1AF}" type="datetimeFigureOut">
              <a:rPr lang="en-US" smtClean="0"/>
              <a:t>4/2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4EBF1-75AD-4EB6-B7CC-5F2E1793C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26134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E1577-C933-41BD-993C-373F4518E1AF}" type="datetimeFigureOut">
              <a:rPr lang="en-US" smtClean="0"/>
              <a:t>4/2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4EBF1-75AD-4EB6-B7CC-5F2E1793C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01579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E1577-C933-41BD-993C-373F4518E1AF}" type="datetimeFigureOut">
              <a:rPr lang="en-US" smtClean="0"/>
              <a:t>4/2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4EBF1-75AD-4EB6-B7CC-5F2E1793C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29137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E1577-C933-41BD-993C-373F4518E1AF}" type="datetimeFigureOut">
              <a:rPr lang="en-US" smtClean="0"/>
              <a:t>4/29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4EBF1-75AD-4EB6-B7CC-5F2E1793C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1439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E1577-C933-41BD-993C-373F4518E1AF}" type="datetimeFigureOut">
              <a:rPr lang="en-US" smtClean="0"/>
              <a:t>4/29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4EBF1-75AD-4EB6-B7CC-5F2E1793C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2893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E1577-C933-41BD-993C-373F4518E1AF}" type="datetimeFigureOut">
              <a:rPr lang="en-US" smtClean="0"/>
              <a:t>4/29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4EBF1-75AD-4EB6-B7CC-5F2E1793C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77736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E1577-C933-41BD-993C-373F4518E1AF}" type="datetimeFigureOut">
              <a:rPr lang="en-US" smtClean="0"/>
              <a:t>4/29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4EBF1-75AD-4EB6-B7CC-5F2E1793C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63069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E1577-C933-41BD-993C-373F4518E1AF}" type="datetimeFigureOut">
              <a:rPr lang="en-US" smtClean="0"/>
              <a:t>4/29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4EBF1-75AD-4EB6-B7CC-5F2E1793C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3474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E1577-C933-41BD-993C-373F4518E1AF}" type="datetimeFigureOut">
              <a:rPr lang="en-US" smtClean="0"/>
              <a:t>4/29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4EBF1-75AD-4EB6-B7CC-5F2E1793C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1701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DBE1577-C933-41BD-993C-373F4518E1AF}" type="datetimeFigureOut">
              <a:rPr lang="en-US" smtClean="0"/>
              <a:t>4/2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E54EBF1-75AD-4EB6-B7CC-5F2E1793C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9487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" name="Group 34">
            <a:extLst>
              <a:ext uri="{FF2B5EF4-FFF2-40B4-BE49-F238E27FC236}">
                <a16:creationId xmlns:a16="http://schemas.microsoft.com/office/drawing/2014/main" id="{FAEC22DF-2DE5-8D18-DCEE-A9A7D6AF5E08}"/>
              </a:ext>
            </a:extLst>
          </p:cNvPr>
          <p:cNvGrpSpPr/>
          <p:nvPr/>
        </p:nvGrpSpPr>
        <p:grpSpPr>
          <a:xfrm>
            <a:off x="1035780" y="1118134"/>
            <a:ext cx="4771051" cy="4774131"/>
            <a:chOff x="1143000" y="1108722"/>
            <a:chExt cx="4771051" cy="4774131"/>
          </a:xfrm>
        </p:grpSpPr>
        <p:pic>
          <p:nvPicPr>
            <p:cNvPr id="2" name="Picture 1" descr="Chart, diagram&#10;&#10;AI-generated content may be incorrect.">
              <a:extLst>
                <a:ext uri="{FF2B5EF4-FFF2-40B4-BE49-F238E27FC236}">
                  <a16:creationId xmlns:a16="http://schemas.microsoft.com/office/drawing/2014/main" id="{6E9EB9D6-B49A-7B4F-2218-C43442C185F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214" t="31940" r="20949" b="31206"/>
            <a:stretch>
              <a:fillRect/>
            </a:stretch>
          </p:blipFill>
          <p:spPr>
            <a:xfrm>
              <a:off x="3733800" y="1752600"/>
              <a:ext cx="2152053" cy="1348005"/>
            </a:xfrm>
            <a:prstGeom prst="rect">
              <a:avLst/>
            </a:prstGeom>
          </p:spPr>
        </p:pic>
        <p:pic>
          <p:nvPicPr>
            <p:cNvPr id="7" name="Picture 6" descr="Diagram&#10;&#10;AI-generated content may be incorrect.">
              <a:extLst>
                <a:ext uri="{FF2B5EF4-FFF2-40B4-BE49-F238E27FC236}">
                  <a16:creationId xmlns:a16="http://schemas.microsoft.com/office/drawing/2014/main" id="{0D274080-2CE9-DF80-3C98-530605F3B26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902" t="31151" r="20261" b="31995"/>
            <a:stretch>
              <a:fillRect/>
            </a:stretch>
          </p:blipFill>
          <p:spPr>
            <a:xfrm>
              <a:off x="1351277" y="1733985"/>
              <a:ext cx="2152053" cy="1348005"/>
            </a:xfrm>
            <a:prstGeom prst="rect">
              <a:avLst/>
            </a:prstGeom>
          </p:spPr>
        </p:pic>
        <p:pic>
          <p:nvPicPr>
            <p:cNvPr id="8" name="Picture 7" descr="Chart, diagram&#10;&#10;AI-generated content may be incorrect.">
              <a:extLst>
                <a:ext uri="{FF2B5EF4-FFF2-40B4-BE49-F238E27FC236}">
                  <a16:creationId xmlns:a16="http://schemas.microsoft.com/office/drawing/2014/main" id="{61CCC64D-74A6-5F30-26E5-D3FFC9C62EA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754" t="31493" r="20408" b="31653"/>
            <a:stretch>
              <a:fillRect/>
            </a:stretch>
          </p:blipFill>
          <p:spPr>
            <a:xfrm>
              <a:off x="1363977" y="3107515"/>
              <a:ext cx="2152054" cy="1348005"/>
            </a:xfrm>
            <a:prstGeom prst="rect">
              <a:avLst/>
            </a:prstGeom>
          </p:spPr>
        </p:pic>
        <p:pic>
          <p:nvPicPr>
            <p:cNvPr id="9" name="Picture 8" descr="Diagram&#10;&#10;AI-generated content may be incorrect.">
              <a:extLst>
                <a:ext uri="{FF2B5EF4-FFF2-40B4-BE49-F238E27FC236}">
                  <a16:creationId xmlns:a16="http://schemas.microsoft.com/office/drawing/2014/main" id="{F1922220-C08F-143E-F8DA-2A8EF090E00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670" t="31965" r="19723" b="31181"/>
            <a:stretch>
              <a:fillRect/>
            </a:stretch>
          </p:blipFill>
          <p:spPr>
            <a:xfrm>
              <a:off x="3733800" y="3113740"/>
              <a:ext cx="2180251" cy="1348005"/>
            </a:xfrm>
            <a:prstGeom prst="rect">
              <a:avLst/>
            </a:prstGeom>
          </p:spPr>
        </p:pic>
        <p:pic>
          <p:nvPicPr>
            <p:cNvPr id="10" name="Picture 9" descr="Chart, diagram&#10;&#10;AI-generated content may be incorrect.">
              <a:extLst>
                <a:ext uri="{FF2B5EF4-FFF2-40B4-BE49-F238E27FC236}">
                  <a16:creationId xmlns:a16="http://schemas.microsoft.com/office/drawing/2014/main" id="{7711C57E-D82C-0AC3-6A86-6D55830B0CA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366" t="31963" r="21302" b="31975"/>
            <a:stretch>
              <a:fillRect/>
            </a:stretch>
          </p:blipFill>
          <p:spPr>
            <a:xfrm>
              <a:off x="1332193" y="4563858"/>
              <a:ext cx="2133600" cy="1318995"/>
            </a:xfrm>
            <a:prstGeom prst="rect">
              <a:avLst/>
            </a:prstGeom>
          </p:spPr>
        </p:pic>
        <p:pic>
          <p:nvPicPr>
            <p:cNvPr id="11" name="Picture 10" descr="Diagram&#10;&#10;AI-generated content may be incorrect.">
              <a:extLst>
                <a:ext uri="{FF2B5EF4-FFF2-40B4-BE49-F238E27FC236}">
                  <a16:creationId xmlns:a16="http://schemas.microsoft.com/office/drawing/2014/main" id="{EEB23F52-C75F-AB4C-9A1F-F400FFADC48A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949" t="31891" r="21801" b="32047"/>
            <a:stretch>
              <a:fillRect/>
            </a:stretch>
          </p:blipFill>
          <p:spPr>
            <a:xfrm>
              <a:off x="3765919" y="4563858"/>
              <a:ext cx="2057399" cy="1318995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78B71A5F-778D-ACDD-9B64-1AA0705C6176}"/>
                </a:ext>
              </a:extLst>
            </p:cNvPr>
            <p:cNvSpPr txBox="1"/>
            <p:nvPr/>
          </p:nvSpPr>
          <p:spPr>
            <a:xfrm>
              <a:off x="1868238" y="1108722"/>
              <a:ext cx="104111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pregulated 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5F13B4B7-89A8-57EC-BCC2-5BC00D8DB0B0}"/>
                </a:ext>
              </a:extLst>
            </p:cNvPr>
            <p:cNvSpPr txBox="1"/>
            <p:nvPr/>
          </p:nvSpPr>
          <p:spPr>
            <a:xfrm>
              <a:off x="4124402" y="1108722"/>
              <a:ext cx="12286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ownregulated 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D1380C0B-7932-7D71-11E0-762342779257}"/>
                </a:ext>
              </a:extLst>
            </p:cNvPr>
            <p:cNvSpPr txBox="1"/>
            <p:nvPr/>
          </p:nvSpPr>
          <p:spPr>
            <a:xfrm rot="16200000">
              <a:off x="1018640" y="2269487"/>
              <a:ext cx="52571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dpi 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5593FAA6-DE14-5DF5-C003-DAC3C2E34C5B}"/>
                </a:ext>
              </a:extLst>
            </p:cNvPr>
            <p:cNvSpPr txBox="1"/>
            <p:nvPr/>
          </p:nvSpPr>
          <p:spPr>
            <a:xfrm rot="16200000">
              <a:off x="1018640" y="3640839"/>
              <a:ext cx="52571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dpi 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3E339413-0C1D-0B80-1982-02D29E180C6A}"/>
                </a:ext>
              </a:extLst>
            </p:cNvPr>
            <p:cNvSpPr txBox="1"/>
            <p:nvPr/>
          </p:nvSpPr>
          <p:spPr>
            <a:xfrm rot="16200000">
              <a:off x="1018640" y="5084855"/>
              <a:ext cx="52571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dpi 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C6C6F35E-785B-4209-319D-3F4B53C3053E}"/>
                </a:ext>
              </a:extLst>
            </p:cNvPr>
            <p:cNvSpPr txBox="1"/>
            <p:nvPr/>
          </p:nvSpPr>
          <p:spPr>
            <a:xfrm>
              <a:off x="1631220" y="1582579"/>
              <a:ext cx="7317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CHFV 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5C71E060-D0D2-B437-5D63-1F15CDCD80D8}"/>
                </a:ext>
              </a:extLst>
            </p:cNvPr>
            <p:cNvSpPr txBox="1"/>
            <p:nvPr/>
          </p:nvSpPr>
          <p:spPr>
            <a:xfrm>
              <a:off x="2516501" y="1582579"/>
              <a:ext cx="680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FTSV 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53CA0DE0-118E-4C1B-74D5-F70CE6576460}"/>
                </a:ext>
              </a:extLst>
            </p:cNvPr>
            <p:cNvSpPr txBox="1"/>
            <p:nvPr/>
          </p:nvSpPr>
          <p:spPr>
            <a:xfrm>
              <a:off x="4023681" y="1561349"/>
              <a:ext cx="7317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CHFV 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D58D01C7-2FC9-A49B-EA80-FC6834B36429}"/>
                </a:ext>
              </a:extLst>
            </p:cNvPr>
            <p:cNvSpPr txBox="1"/>
            <p:nvPr/>
          </p:nvSpPr>
          <p:spPr>
            <a:xfrm>
              <a:off x="4907820" y="1561349"/>
              <a:ext cx="680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FTSV </a:t>
              </a:r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EC922FD7-E12A-B51F-9639-CD8AD6523BF4}"/>
              </a:ext>
            </a:extLst>
          </p:cNvPr>
          <p:cNvSpPr txBox="1"/>
          <p:nvPr/>
        </p:nvSpPr>
        <p:spPr>
          <a:xfrm>
            <a:off x="423508" y="6096000"/>
            <a:ext cx="6010984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Aft>
                <a:spcPts val="800"/>
              </a:spcAft>
              <a:buNone/>
            </a:pPr>
            <a:r>
              <a:rPr lang="en-US" sz="12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</a:t>
            </a:r>
            <a:r>
              <a:rPr lang="en-US" sz="1200" b="1" kern="10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ure S1</a:t>
            </a:r>
            <a:r>
              <a:rPr lang="en-US" sz="12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 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Venn diagrams illustrate the overlap and divergence in gene expression changes between CCHFV and SFTSV on days 2, 3, and 4 post-infection. Significant overlap in differentially expressed genes (DEGs) between the two viruses increases at later time points. Genes with more than 2-fold changes were used for comparison.</a:t>
            </a:r>
            <a:endParaRPr lang="en-US" sz="12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767357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76a3f6ad-3d9b-49ad-9486-10bfd8fef73e}" enabled="1" method="Privileged" siteId="{8903a443-af33-4ed4-acf5-ee613bcb2f59}" removed="0"/>
  <clbl:label id="{a17f8ab9-bc70-4901-a8ac-c4b71563637c}" enabled="0" method="" siteId="{a17f8ab9-bc70-4901-a8ac-c4b71563637c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647</TotalTime>
  <Words>68</Words>
  <Application>Microsoft Office PowerPoint</Application>
  <PresentationFormat>A4 Paper (210x297 mm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enchegowda, Doreswamy CTR (USA)</dc:creator>
  <cp:lastModifiedBy>MDPI</cp:lastModifiedBy>
  <cp:revision>6</cp:revision>
  <cp:lastPrinted>2025-12-05T19:14:22Z</cp:lastPrinted>
  <dcterms:created xsi:type="dcterms:W3CDTF">2025-10-29T17:36:32Z</dcterms:created>
  <dcterms:modified xsi:type="dcterms:W3CDTF">2026-04-29T06:36:08Z</dcterms:modified>
</cp:coreProperties>
</file>